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4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69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Merged_data2014Dec\Research\Analysis\Virtual_support\ALL_RNA-Seq\ForManuscript\Frontiers_Word_Templates\20190315\Read_TNumber.ta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Merged_data2014Dec\Research\Analysis\Virtual_support\ALL_RNA-Seq\ForManuscript\Frontiers_Word_Templates\20190315\Read_SNPs.ta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Read_TNumber!$C$2:$C$151</c:f>
              <c:numCache>
                <c:formatCode>General</c:formatCode>
                <c:ptCount val="150"/>
                <c:pt idx="0">
                  <c:v>5413719</c:v>
                </c:pt>
                <c:pt idx="1">
                  <c:v>4224202</c:v>
                </c:pt>
                <c:pt idx="2">
                  <c:v>5639781</c:v>
                </c:pt>
                <c:pt idx="3">
                  <c:v>4898839</c:v>
                </c:pt>
                <c:pt idx="4">
                  <c:v>5518089</c:v>
                </c:pt>
                <c:pt idx="5">
                  <c:v>4901534</c:v>
                </c:pt>
                <c:pt idx="6">
                  <c:v>4573272</c:v>
                </c:pt>
                <c:pt idx="7">
                  <c:v>4976017</c:v>
                </c:pt>
                <c:pt idx="8">
                  <c:v>4449875</c:v>
                </c:pt>
                <c:pt idx="9">
                  <c:v>4974244</c:v>
                </c:pt>
                <c:pt idx="10">
                  <c:v>3984592</c:v>
                </c:pt>
                <c:pt idx="11">
                  <c:v>5793453</c:v>
                </c:pt>
                <c:pt idx="12">
                  <c:v>4926323</c:v>
                </c:pt>
                <c:pt idx="13">
                  <c:v>4720157</c:v>
                </c:pt>
                <c:pt idx="14">
                  <c:v>4400480</c:v>
                </c:pt>
                <c:pt idx="15">
                  <c:v>5153681</c:v>
                </c:pt>
                <c:pt idx="16">
                  <c:v>5038838</c:v>
                </c:pt>
                <c:pt idx="17">
                  <c:v>5735964</c:v>
                </c:pt>
                <c:pt idx="18">
                  <c:v>4680384</c:v>
                </c:pt>
                <c:pt idx="19">
                  <c:v>5088936</c:v>
                </c:pt>
                <c:pt idx="20">
                  <c:v>5029947</c:v>
                </c:pt>
                <c:pt idx="21">
                  <c:v>4590477</c:v>
                </c:pt>
                <c:pt idx="22">
                  <c:v>5216631</c:v>
                </c:pt>
                <c:pt idx="23">
                  <c:v>3588816</c:v>
                </c:pt>
                <c:pt idx="24">
                  <c:v>4408694</c:v>
                </c:pt>
                <c:pt idx="25">
                  <c:v>5004262</c:v>
                </c:pt>
                <c:pt idx="26">
                  <c:v>3641637</c:v>
                </c:pt>
                <c:pt idx="27">
                  <c:v>4770242</c:v>
                </c:pt>
                <c:pt idx="28">
                  <c:v>5826999</c:v>
                </c:pt>
                <c:pt idx="29">
                  <c:v>5072641</c:v>
                </c:pt>
                <c:pt idx="30">
                  <c:v>7617686</c:v>
                </c:pt>
                <c:pt idx="31">
                  <c:v>3830107</c:v>
                </c:pt>
                <c:pt idx="32">
                  <c:v>7881698</c:v>
                </c:pt>
                <c:pt idx="33">
                  <c:v>5049686</c:v>
                </c:pt>
                <c:pt idx="34">
                  <c:v>5856428</c:v>
                </c:pt>
                <c:pt idx="35">
                  <c:v>7774891</c:v>
                </c:pt>
                <c:pt idx="36">
                  <c:v>7241198</c:v>
                </c:pt>
                <c:pt idx="37">
                  <c:v>4344576</c:v>
                </c:pt>
                <c:pt idx="38">
                  <c:v>3817849</c:v>
                </c:pt>
                <c:pt idx="39">
                  <c:v>4904345</c:v>
                </c:pt>
                <c:pt idx="40">
                  <c:v>6119593</c:v>
                </c:pt>
                <c:pt idx="41">
                  <c:v>4020516</c:v>
                </c:pt>
                <c:pt idx="42">
                  <c:v>5139755</c:v>
                </c:pt>
                <c:pt idx="43">
                  <c:v>5369217</c:v>
                </c:pt>
                <c:pt idx="44">
                  <c:v>5621276</c:v>
                </c:pt>
                <c:pt idx="45">
                  <c:v>5387023</c:v>
                </c:pt>
                <c:pt idx="46">
                  <c:v>4881337</c:v>
                </c:pt>
                <c:pt idx="47">
                  <c:v>5127554</c:v>
                </c:pt>
                <c:pt idx="48">
                  <c:v>3172600</c:v>
                </c:pt>
                <c:pt idx="49">
                  <c:v>7599158</c:v>
                </c:pt>
                <c:pt idx="50">
                  <c:v>4692637</c:v>
                </c:pt>
                <c:pt idx="51">
                  <c:v>5662829</c:v>
                </c:pt>
                <c:pt idx="52">
                  <c:v>5571636</c:v>
                </c:pt>
                <c:pt idx="53">
                  <c:v>7287654</c:v>
                </c:pt>
                <c:pt idx="54">
                  <c:v>5894836</c:v>
                </c:pt>
                <c:pt idx="55">
                  <c:v>4978691</c:v>
                </c:pt>
                <c:pt idx="56">
                  <c:v>5335034</c:v>
                </c:pt>
                <c:pt idx="57">
                  <c:v>5285897</c:v>
                </c:pt>
                <c:pt idx="58">
                  <c:v>5297736</c:v>
                </c:pt>
                <c:pt idx="59">
                  <c:v>4639380</c:v>
                </c:pt>
                <c:pt idx="60">
                  <c:v>5096964</c:v>
                </c:pt>
                <c:pt idx="61">
                  <c:v>4940511</c:v>
                </c:pt>
                <c:pt idx="62">
                  <c:v>10130120</c:v>
                </c:pt>
                <c:pt idx="63">
                  <c:v>6326299</c:v>
                </c:pt>
                <c:pt idx="64">
                  <c:v>5595236</c:v>
                </c:pt>
                <c:pt idx="65">
                  <c:v>4606947</c:v>
                </c:pt>
                <c:pt idx="66">
                  <c:v>5952439</c:v>
                </c:pt>
                <c:pt idx="67">
                  <c:v>6667651</c:v>
                </c:pt>
                <c:pt idx="68">
                  <c:v>4108688</c:v>
                </c:pt>
                <c:pt idx="69">
                  <c:v>3257777</c:v>
                </c:pt>
                <c:pt idx="70">
                  <c:v>4837037</c:v>
                </c:pt>
                <c:pt idx="71">
                  <c:v>4645889</c:v>
                </c:pt>
                <c:pt idx="72">
                  <c:v>5302412</c:v>
                </c:pt>
                <c:pt idx="73">
                  <c:v>4772738</c:v>
                </c:pt>
                <c:pt idx="74">
                  <c:v>4922497</c:v>
                </c:pt>
                <c:pt idx="75">
                  <c:v>5451323</c:v>
                </c:pt>
                <c:pt idx="76">
                  <c:v>4633275</c:v>
                </c:pt>
                <c:pt idx="77">
                  <c:v>4426495</c:v>
                </c:pt>
                <c:pt idx="78">
                  <c:v>4728613</c:v>
                </c:pt>
                <c:pt idx="79">
                  <c:v>5644901</c:v>
                </c:pt>
                <c:pt idx="80">
                  <c:v>3413313</c:v>
                </c:pt>
                <c:pt idx="81">
                  <c:v>5373512</c:v>
                </c:pt>
                <c:pt idx="82">
                  <c:v>6581757</c:v>
                </c:pt>
                <c:pt idx="83">
                  <c:v>6129419</c:v>
                </c:pt>
                <c:pt idx="84">
                  <c:v>7494887</c:v>
                </c:pt>
                <c:pt idx="85">
                  <c:v>8672944</c:v>
                </c:pt>
                <c:pt idx="86">
                  <c:v>3922011</c:v>
                </c:pt>
                <c:pt idx="87">
                  <c:v>4141270</c:v>
                </c:pt>
                <c:pt idx="88">
                  <c:v>4067120</c:v>
                </c:pt>
                <c:pt idx="89">
                  <c:v>8479621</c:v>
                </c:pt>
                <c:pt idx="90">
                  <c:v>5030418</c:v>
                </c:pt>
                <c:pt idx="91">
                  <c:v>5455202</c:v>
                </c:pt>
                <c:pt idx="92">
                  <c:v>5461419</c:v>
                </c:pt>
                <c:pt idx="93">
                  <c:v>4543149</c:v>
                </c:pt>
                <c:pt idx="94">
                  <c:v>4808729</c:v>
                </c:pt>
                <c:pt idx="95">
                  <c:v>4364931</c:v>
                </c:pt>
                <c:pt idx="96">
                  <c:v>5859698</c:v>
                </c:pt>
                <c:pt idx="97">
                  <c:v>4117957</c:v>
                </c:pt>
                <c:pt idx="98">
                  <c:v>3305675</c:v>
                </c:pt>
                <c:pt idx="99">
                  <c:v>4360971</c:v>
                </c:pt>
                <c:pt idx="100">
                  <c:v>4374541</c:v>
                </c:pt>
                <c:pt idx="101">
                  <c:v>4401674</c:v>
                </c:pt>
                <c:pt idx="102">
                  <c:v>3552218</c:v>
                </c:pt>
                <c:pt idx="103">
                  <c:v>5049285</c:v>
                </c:pt>
                <c:pt idx="104">
                  <c:v>4573143</c:v>
                </c:pt>
                <c:pt idx="105">
                  <c:v>4261847</c:v>
                </c:pt>
                <c:pt idx="106">
                  <c:v>4854163</c:v>
                </c:pt>
                <c:pt idx="107">
                  <c:v>5277492</c:v>
                </c:pt>
                <c:pt idx="108">
                  <c:v>5817416</c:v>
                </c:pt>
                <c:pt idx="109">
                  <c:v>4950283</c:v>
                </c:pt>
                <c:pt idx="110">
                  <c:v>4906065</c:v>
                </c:pt>
                <c:pt idx="111">
                  <c:v>4273255</c:v>
                </c:pt>
                <c:pt idx="112">
                  <c:v>4523777</c:v>
                </c:pt>
                <c:pt idx="113">
                  <c:v>4789448</c:v>
                </c:pt>
                <c:pt idx="114">
                  <c:v>4134803</c:v>
                </c:pt>
                <c:pt idx="115">
                  <c:v>5545591</c:v>
                </c:pt>
                <c:pt idx="116">
                  <c:v>5188322</c:v>
                </c:pt>
                <c:pt idx="117">
                  <c:v>4561752</c:v>
                </c:pt>
                <c:pt idx="118">
                  <c:v>3706303</c:v>
                </c:pt>
                <c:pt idx="119">
                  <c:v>5316842</c:v>
                </c:pt>
                <c:pt idx="120">
                  <c:v>5744095</c:v>
                </c:pt>
                <c:pt idx="121">
                  <c:v>4740448</c:v>
                </c:pt>
                <c:pt idx="122">
                  <c:v>7589096</c:v>
                </c:pt>
                <c:pt idx="123">
                  <c:v>4879696</c:v>
                </c:pt>
                <c:pt idx="124">
                  <c:v>5105597</c:v>
                </c:pt>
                <c:pt idx="125">
                  <c:v>4958456</c:v>
                </c:pt>
                <c:pt idx="126">
                  <c:v>5406677</c:v>
                </c:pt>
                <c:pt idx="127">
                  <c:v>5510918</c:v>
                </c:pt>
                <c:pt idx="128">
                  <c:v>5728399</c:v>
                </c:pt>
                <c:pt idx="129">
                  <c:v>7606877</c:v>
                </c:pt>
                <c:pt idx="130">
                  <c:v>5170227</c:v>
                </c:pt>
                <c:pt idx="131">
                  <c:v>5237753</c:v>
                </c:pt>
                <c:pt idx="132">
                  <c:v>2609932</c:v>
                </c:pt>
                <c:pt idx="133">
                  <c:v>4957145</c:v>
                </c:pt>
                <c:pt idx="134">
                  <c:v>3579614</c:v>
                </c:pt>
                <c:pt idx="135">
                  <c:v>2982743</c:v>
                </c:pt>
                <c:pt idx="136">
                  <c:v>4053006</c:v>
                </c:pt>
                <c:pt idx="137">
                  <c:v>3828532</c:v>
                </c:pt>
                <c:pt idx="138">
                  <c:v>4638912</c:v>
                </c:pt>
                <c:pt idx="139">
                  <c:v>4704941</c:v>
                </c:pt>
                <c:pt idx="140">
                  <c:v>4444776</c:v>
                </c:pt>
                <c:pt idx="141">
                  <c:v>5341874</c:v>
                </c:pt>
                <c:pt idx="142">
                  <c:v>4270734</c:v>
                </c:pt>
                <c:pt idx="143">
                  <c:v>4198363</c:v>
                </c:pt>
                <c:pt idx="144">
                  <c:v>5246446</c:v>
                </c:pt>
                <c:pt idx="145">
                  <c:v>5074899</c:v>
                </c:pt>
                <c:pt idx="146">
                  <c:v>4922693</c:v>
                </c:pt>
                <c:pt idx="147">
                  <c:v>4361991</c:v>
                </c:pt>
                <c:pt idx="148">
                  <c:v>5615316</c:v>
                </c:pt>
                <c:pt idx="149">
                  <c:v>5048648</c:v>
                </c:pt>
              </c:numCache>
            </c:numRef>
          </c:xVal>
          <c:yVal>
            <c:numRef>
              <c:f>Read_TNumber!$B$2:$B$151</c:f>
              <c:numCache>
                <c:formatCode>General</c:formatCode>
                <c:ptCount val="150"/>
                <c:pt idx="0">
                  <c:v>56966</c:v>
                </c:pt>
                <c:pt idx="1">
                  <c:v>53364</c:v>
                </c:pt>
                <c:pt idx="2">
                  <c:v>58858</c:v>
                </c:pt>
                <c:pt idx="3">
                  <c:v>57694</c:v>
                </c:pt>
                <c:pt idx="4">
                  <c:v>62294</c:v>
                </c:pt>
                <c:pt idx="5">
                  <c:v>57534</c:v>
                </c:pt>
                <c:pt idx="6">
                  <c:v>56810</c:v>
                </c:pt>
                <c:pt idx="7">
                  <c:v>67292</c:v>
                </c:pt>
                <c:pt idx="8">
                  <c:v>60438</c:v>
                </c:pt>
                <c:pt idx="9">
                  <c:v>59124</c:v>
                </c:pt>
                <c:pt idx="10">
                  <c:v>55107</c:v>
                </c:pt>
                <c:pt idx="11">
                  <c:v>63063</c:v>
                </c:pt>
                <c:pt idx="12">
                  <c:v>57878</c:v>
                </c:pt>
                <c:pt idx="13">
                  <c:v>56012</c:v>
                </c:pt>
                <c:pt idx="14">
                  <c:v>55914</c:v>
                </c:pt>
                <c:pt idx="15">
                  <c:v>57741</c:v>
                </c:pt>
                <c:pt idx="16">
                  <c:v>65896</c:v>
                </c:pt>
                <c:pt idx="17">
                  <c:v>60981</c:v>
                </c:pt>
                <c:pt idx="18">
                  <c:v>58352</c:v>
                </c:pt>
                <c:pt idx="19">
                  <c:v>73127</c:v>
                </c:pt>
                <c:pt idx="20">
                  <c:v>59780</c:v>
                </c:pt>
                <c:pt idx="21">
                  <c:v>71305</c:v>
                </c:pt>
                <c:pt idx="22">
                  <c:v>56579</c:v>
                </c:pt>
                <c:pt idx="23">
                  <c:v>66780</c:v>
                </c:pt>
                <c:pt idx="24">
                  <c:v>53181</c:v>
                </c:pt>
                <c:pt idx="25">
                  <c:v>72218</c:v>
                </c:pt>
                <c:pt idx="26">
                  <c:v>66064</c:v>
                </c:pt>
                <c:pt idx="27">
                  <c:v>49234</c:v>
                </c:pt>
                <c:pt idx="28">
                  <c:v>69632</c:v>
                </c:pt>
                <c:pt idx="29">
                  <c:v>57385</c:v>
                </c:pt>
                <c:pt idx="30">
                  <c:v>77638</c:v>
                </c:pt>
                <c:pt idx="31">
                  <c:v>55016</c:v>
                </c:pt>
                <c:pt idx="32">
                  <c:v>76215</c:v>
                </c:pt>
                <c:pt idx="33">
                  <c:v>63515</c:v>
                </c:pt>
                <c:pt idx="34">
                  <c:v>71425</c:v>
                </c:pt>
                <c:pt idx="35">
                  <c:v>73788</c:v>
                </c:pt>
                <c:pt idx="36">
                  <c:v>74237</c:v>
                </c:pt>
                <c:pt idx="37">
                  <c:v>61579</c:v>
                </c:pt>
                <c:pt idx="38">
                  <c:v>63166</c:v>
                </c:pt>
                <c:pt idx="39">
                  <c:v>59290</c:v>
                </c:pt>
                <c:pt idx="40">
                  <c:v>65102</c:v>
                </c:pt>
                <c:pt idx="41">
                  <c:v>62295</c:v>
                </c:pt>
                <c:pt idx="42">
                  <c:v>58308</c:v>
                </c:pt>
                <c:pt idx="43">
                  <c:v>71380</c:v>
                </c:pt>
                <c:pt idx="44">
                  <c:v>59445</c:v>
                </c:pt>
                <c:pt idx="45">
                  <c:v>68997</c:v>
                </c:pt>
                <c:pt idx="46">
                  <c:v>57142</c:v>
                </c:pt>
                <c:pt idx="47">
                  <c:v>68266</c:v>
                </c:pt>
                <c:pt idx="48">
                  <c:v>41018</c:v>
                </c:pt>
                <c:pt idx="49">
                  <c:v>72839</c:v>
                </c:pt>
                <c:pt idx="50">
                  <c:v>57290</c:v>
                </c:pt>
                <c:pt idx="51">
                  <c:v>71954</c:v>
                </c:pt>
                <c:pt idx="52">
                  <c:v>61475</c:v>
                </c:pt>
                <c:pt idx="53">
                  <c:v>71345</c:v>
                </c:pt>
                <c:pt idx="54">
                  <c:v>69434</c:v>
                </c:pt>
                <c:pt idx="55">
                  <c:v>64638</c:v>
                </c:pt>
                <c:pt idx="56">
                  <c:v>67545</c:v>
                </c:pt>
                <c:pt idx="57">
                  <c:v>66211</c:v>
                </c:pt>
                <c:pt idx="58">
                  <c:v>61444</c:v>
                </c:pt>
                <c:pt idx="59">
                  <c:v>61284</c:v>
                </c:pt>
                <c:pt idx="60">
                  <c:v>63377</c:v>
                </c:pt>
                <c:pt idx="61">
                  <c:v>56657</c:v>
                </c:pt>
                <c:pt idx="62">
                  <c:v>70068</c:v>
                </c:pt>
                <c:pt idx="63">
                  <c:v>59971</c:v>
                </c:pt>
                <c:pt idx="64">
                  <c:v>59490</c:v>
                </c:pt>
                <c:pt idx="65">
                  <c:v>53325</c:v>
                </c:pt>
                <c:pt idx="66">
                  <c:v>58656</c:v>
                </c:pt>
                <c:pt idx="67">
                  <c:v>72856</c:v>
                </c:pt>
                <c:pt idx="68">
                  <c:v>49414</c:v>
                </c:pt>
                <c:pt idx="69">
                  <c:v>59030</c:v>
                </c:pt>
                <c:pt idx="70">
                  <c:v>59011</c:v>
                </c:pt>
                <c:pt idx="71">
                  <c:v>53232</c:v>
                </c:pt>
                <c:pt idx="72">
                  <c:v>60833</c:v>
                </c:pt>
                <c:pt idx="73">
                  <c:v>51311</c:v>
                </c:pt>
                <c:pt idx="74">
                  <c:v>60662</c:v>
                </c:pt>
                <c:pt idx="75">
                  <c:v>60135</c:v>
                </c:pt>
                <c:pt idx="76">
                  <c:v>61801</c:v>
                </c:pt>
                <c:pt idx="77">
                  <c:v>59237</c:v>
                </c:pt>
                <c:pt idx="78">
                  <c:v>65277</c:v>
                </c:pt>
                <c:pt idx="79">
                  <c:v>67530</c:v>
                </c:pt>
                <c:pt idx="80">
                  <c:v>59389</c:v>
                </c:pt>
                <c:pt idx="81">
                  <c:v>60967</c:v>
                </c:pt>
                <c:pt idx="82">
                  <c:v>71461</c:v>
                </c:pt>
                <c:pt idx="83">
                  <c:v>68289</c:v>
                </c:pt>
                <c:pt idx="84">
                  <c:v>72692</c:v>
                </c:pt>
                <c:pt idx="85">
                  <c:v>74545</c:v>
                </c:pt>
                <c:pt idx="86">
                  <c:v>54715</c:v>
                </c:pt>
                <c:pt idx="87">
                  <c:v>61470</c:v>
                </c:pt>
                <c:pt idx="88">
                  <c:v>61700</c:v>
                </c:pt>
                <c:pt idx="89">
                  <c:v>75031</c:v>
                </c:pt>
                <c:pt idx="90">
                  <c:v>68029</c:v>
                </c:pt>
                <c:pt idx="91">
                  <c:v>69993</c:v>
                </c:pt>
                <c:pt idx="92">
                  <c:v>72343</c:v>
                </c:pt>
                <c:pt idx="93">
                  <c:v>55519</c:v>
                </c:pt>
                <c:pt idx="94">
                  <c:v>70524</c:v>
                </c:pt>
                <c:pt idx="95">
                  <c:v>62515</c:v>
                </c:pt>
                <c:pt idx="96">
                  <c:v>68912</c:v>
                </c:pt>
                <c:pt idx="97">
                  <c:v>72679</c:v>
                </c:pt>
                <c:pt idx="98">
                  <c:v>59259</c:v>
                </c:pt>
                <c:pt idx="99">
                  <c:v>52017</c:v>
                </c:pt>
                <c:pt idx="100">
                  <c:v>66661</c:v>
                </c:pt>
                <c:pt idx="101">
                  <c:v>64652</c:v>
                </c:pt>
                <c:pt idx="102">
                  <c:v>43163</c:v>
                </c:pt>
                <c:pt idx="103">
                  <c:v>64539</c:v>
                </c:pt>
                <c:pt idx="104">
                  <c:v>49423</c:v>
                </c:pt>
                <c:pt idx="105">
                  <c:v>60430</c:v>
                </c:pt>
                <c:pt idx="106">
                  <c:v>50180</c:v>
                </c:pt>
                <c:pt idx="107">
                  <c:v>66007</c:v>
                </c:pt>
                <c:pt idx="108">
                  <c:v>45375</c:v>
                </c:pt>
                <c:pt idx="109">
                  <c:v>62159</c:v>
                </c:pt>
                <c:pt idx="110">
                  <c:v>63232</c:v>
                </c:pt>
                <c:pt idx="111">
                  <c:v>57356</c:v>
                </c:pt>
                <c:pt idx="112">
                  <c:v>59340</c:v>
                </c:pt>
                <c:pt idx="113">
                  <c:v>55774</c:v>
                </c:pt>
                <c:pt idx="114">
                  <c:v>61589</c:v>
                </c:pt>
                <c:pt idx="115">
                  <c:v>63687</c:v>
                </c:pt>
                <c:pt idx="116">
                  <c:v>57850</c:v>
                </c:pt>
                <c:pt idx="117">
                  <c:v>56319</c:v>
                </c:pt>
                <c:pt idx="118">
                  <c:v>57094</c:v>
                </c:pt>
                <c:pt idx="119">
                  <c:v>60885</c:v>
                </c:pt>
                <c:pt idx="120">
                  <c:v>59038</c:v>
                </c:pt>
                <c:pt idx="121">
                  <c:v>66296</c:v>
                </c:pt>
                <c:pt idx="122">
                  <c:v>66573</c:v>
                </c:pt>
                <c:pt idx="123">
                  <c:v>57774</c:v>
                </c:pt>
                <c:pt idx="124">
                  <c:v>57733</c:v>
                </c:pt>
                <c:pt idx="125">
                  <c:v>55851</c:v>
                </c:pt>
                <c:pt idx="126">
                  <c:v>56684</c:v>
                </c:pt>
                <c:pt idx="127">
                  <c:v>61488</c:v>
                </c:pt>
                <c:pt idx="128">
                  <c:v>60049</c:v>
                </c:pt>
                <c:pt idx="129">
                  <c:v>66731</c:v>
                </c:pt>
                <c:pt idx="130">
                  <c:v>53842</c:v>
                </c:pt>
                <c:pt idx="131">
                  <c:v>59923</c:v>
                </c:pt>
                <c:pt idx="132">
                  <c:v>50000</c:v>
                </c:pt>
                <c:pt idx="133">
                  <c:v>64868</c:v>
                </c:pt>
                <c:pt idx="134">
                  <c:v>60249</c:v>
                </c:pt>
                <c:pt idx="135">
                  <c:v>49817</c:v>
                </c:pt>
                <c:pt idx="136">
                  <c:v>40189</c:v>
                </c:pt>
                <c:pt idx="137">
                  <c:v>53655</c:v>
                </c:pt>
                <c:pt idx="138">
                  <c:v>42784</c:v>
                </c:pt>
                <c:pt idx="139">
                  <c:v>57121</c:v>
                </c:pt>
                <c:pt idx="140">
                  <c:v>42765</c:v>
                </c:pt>
                <c:pt idx="141">
                  <c:v>61661</c:v>
                </c:pt>
                <c:pt idx="142">
                  <c:v>42043</c:v>
                </c:pt>
                <c:pt idx="143">
                  <c:v>56739</c:v>
                </c:pt>
                <c:pt idx="144">
                  <c:v>45728</c:v>
                </c:pt>
                <c:pt idx="145">
                  <c:v>60603</c:v>
                </c:pt>
                <c:pt idx="146">
                  <c:v>56516</c:v>
                </c:pt>
                <c:pt idx="147">
                  <c:v>55079</c:v>
                </c:pt>
                <c:pt idx="148">
                  <c:v>64444</c:v>
                </c:pt>
                <c:pt idx="149">
                  <c:v>6418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C21-4F31-9E4E-98DCCD7094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1777440"/>
        <c:axId val="36980656"/>
      </c:scatterChart>
      <c:valAx>
        <c:axId val="411777440"/>
        <c:scaling>
          <c:orientation val="minMax"/>
          <c:min val="20000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6980656"/>
        <c:crosses val="autoZero"/>
        <c:crossBetween val="midCat"/>
        <c:majorUnit val="2000000"/>
      </c:valAx>
      <c:valAx>
        <c:axId val="36980656"/>
        <c:scaling>
          <c:orientation val="minMax"/>
          <c:min val="4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11777440"/>
        <c:crosses val="autoZero"/>
        <c:crossBetween val="midCat"/>
        <c:majorUnit val="1000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Read_SNPs!$E$2:$E$69</c:f>
              <c:numCache>
                <c:formatCode>General</c:formatCode>
                <c:ptCount val="68"/>
                <c:pt idx="0">
                  <c:v>5413719</c:v>
                </c:pt>
                <c:pt idx="1">
                  <c:v>4224202</c:v>
                </c:pt>
                <c:pt idx="2">
                  <c:v>5639781</c:v>
                </c:pt>
                <c:pt idx="3">
                  <c:v>4898839</c:v>
                </c:pt>
                <c:pt idx="4">
                  <c:v>5518089</c:v>
                </c:pt>
                <c:pt idx="5">
                  <c:v>4901534</c:v>
                </c:pt>
                <c:pt idx="6">
                  <c:v>4573272</c:v>
                </c:pt>
                <c:pt idx="7">
                  <c:v>4974244</c:v>
                </c:pt>
                <c:pt idx="8">
                  <c:v>3984592</c:v>
                </c:pt>
                <c:pt idx="9">
                  <c:v>5793453</c:v>
                </c:pt>
                <c:pt idx="10">
                  <c:v>4926323</c:v>
                </c:pt>
                <c:pt idx="11">
                  <c:v>4720157</c:v>
                </c:pt>
                <c:pt idx="12">
                  <c:v>4400480</c:v>
                </c:pt>
                <c:pt idx="13">
                  <c:v>5153681</c:v>
                </c:pt>
                <c:pt idx="14">
                  <c:v>4680384</c:v>
                </c:pt>
                <c:pt idx="15">
                  <c:v>7287654</c:v>
                </c:pt>
                <c:pt idx="16">
                  <c:v>5335034</c:v>
                </c:pt>
                <c:pt idx="17">
                  <c:v>5285897</c:v>
                </c:pt>
                <c:pt idx="18">
                  <c:v>5297736</c:v>
                </c:pt>
                <c:pt idx="19">
                  <c:v>4639380</c:v>
                </c:pt>
                <c:pt idx="20">
                  <c:v>5096964</c:v>
                </c:pt>
                <c:pt idx="21">
                  <c:v>4940511</c:v>
                </c:pt>
                <c:pt idx="22">
                  <c:v>10130120</c:v>
                </c:pt>
                <c:pt idx="23">
                  <c:v>6326299</c:v>
                </c:pt>
                <c:pt idx="24">
                  <c:v>5952439</c:v>
                </c:pt>
                <c:pt idx="25">
                  <c:v>3257777</c:v>
                </c:pt>
                <c:pt idx="26">
                  <c:v>4633275</c:v>
                </c:pt>
                <c:pt idx="27">
                  <c:v>4426495</c:v>
                </c:pt>
                <c:pt idx="28">
                  <c:v>4728613</c:v>
                </c:pt>
                <c:pt idx="29">
                  <c:v>5644901</c:v>
                </c:pt>
                <c:pt idx="30">
                  <c:v>3413313</c:v>
                </c:pt>
                <c:pt idx="31">
                  <c:v>5373512</c:v>
                </c:pt>
                <c:pt idx="32">
                  <c:v>7494887</c:v>
                </c:pt>
                <c:pt idx="33">
                  <c:v>8672944</c:v>
                </c:pt>
                <c:pt idx="34">
                  <c:v>3922011</c:v>
                </c:pt>
                <c:pt idx="35">
                  <c:v>4141270</c:v>
                </c:pt>
                <c:pt idx="36">
                  <c:v>4067120</c:v>
                </c:pt>
                <c:pt idx="37">
                  <c:v>8479621</c:v>
                </c:pt>
                <c:pt idx="38">
                  <c:v>5030418</c:v>
                </c:pt>
                <c:pt idx="39">
                  <c:v>5455202</c:v>
                </c:pt>
                <c:pt idx="40">
                  <c:v>4808729</c:v>
                </c:pt>
                <c:pt idx="41">
                  <c:v>4117957</c:v>
                </c:pt>
                <c:pt idx="42">
                  <c:v>4374541</c:v>
                </c:pt>
                <c:pt idx="43">
                  <c:v>5277492</c:v>
                </c:pt>
                <c:pt idx="44">
                  <c:v>5817416</c:v>
                </c:pt>
                <c:pt idx="45">
                  <c:v>4950283</c:v>
                </c:pt>
                <c:pt idx="46">
                  <c:v>4906065</c:v>
                </c:pt>
                <c:pt idx="47">
                  <c:v>4789448</c:v>
                </c:pt>
                <c:pt idx="48">
                  <c:v>4134803</c:v>
                </c:pt>
                <c:pt idx="49">
                  <c:v>5545591</c:v>
                </c:pt>
                <c:pt idx="50">
                  <c:v>5188322</c:v>
                </c:pt>
                <c:pt idx="51">
                  <c:v>4561752</c:v>
                </c:pt>
                <c:pt idx="52">
                  <c:v>3706303</c:v>
                </c:pt>
                <c:pt idx="53">
                  <c:v>5316842</c:v>
                </c:pt>
                <c:pt idx="54">
                  <c:v>5744095</c:v>
                </c:pt>
                <c:pt idx="55">
                  <c:v>4879696</c:v>
                </c:pt>
                <c:pt idx="56">
                  <c:v>5105597</c:v>
                </c:pt>
                <c:pt idx="57">
                  <c:v>4958456</c:v>
                </c:pt>
                <c:pt idx="58">
                  <c:v>5406677</c:v>
                </c:pt>
                <c:pt idx="59">
                  <c:v>5510918</c:v>
                </c:pt>
                <c:pt idx="60">
                  <c:v>5728399</c:v>
                </c:pt>
                <c:pt idx="61">
                  <c:v>7606877</c:v>
                </c:pt>
                <c:pt idx="62">
                  <c:v>5170227</c:v>
                </c:pt>
                <c:pt idx="63">
                  <c:v>5237753</c:v>
                </c:pt>
                <c:pt idx="64">
                  <c:v>2609932</c:v>
                </c:pt>
                <c:pt idx="65">
                  <c:v>2982743</c:v>
                </c:pt>
                <c:pt idx="66">
                  <c:v>4922693</c:v>
                </c:pt>
                <c:pt idx="67">
                  <c:v>4361991</c:v>
                </c:pt>
              </c:numCache>
            </c:numRef>
          </c:xVal>
          <c:yVal>
            <c:numRef>
              <c:f>Read_SNPs!$B$2:$B$69</c:f>
              <c:numCache>
                <c:formatCode>General</c:formatCode>
                <c:ptCount val="68"/>
                <c:pt idx="0">
                  <c:v>21713</c:v>
                </c:pt>
                <c:pt idx="1">
                  <c:v>16575</c:v>
                </c:pt>
                <c:pt idx="2">
                  <c:v>18617</c:v>
                </c:pt>
                <c:pt idx="3">
                  <c:v>18085</c:v>
                </c:pt>
                <c:pt idx="4">
                  <c:v>20976</c:v>
                </c:pt>
                <c:pt idx="5">
                  <c:v>17830</c:v>
                </c:pt>
                <c:pt idx="6">
                  <c:v>16107</c:v>
                </c:pt>
                <c:pt idx="7">
                  <c:v>16519</c:v>
                </c:pt>
                <c:pt idx="8">
                  <c:v>15776</c:v>
                </c:pt>
                <c:pt idx="9">
                  <c:v>15556</c:v>
                </c:pt>
                <c:pt idx="10">
                  <c:v>15174</c:v>
                </c:pt>
                <c:pt idx="11">
                  <c:v>13939</c:v>
                </c:pt>
                <c:pt idx="12">
                  <c:v>20886</c:v>
                </c:pt>
                <c:pt idx="13">
                  <c:v>16297</c:v>
                </c:pt>
                <c:pt idx="14">
                  <c:v>13125</c:v>
                </c:pt>
                <c:pt idx="15">
                  <c:v>16488</c:v>
                </c:pt>
                <c:pt idx="16">
                  <c:v>15587</c:v>
                </c:pt>
                <c:pt idx="17">
                  <c:v>16689</c:v>
                </c:pt>
                <c:pt idx="18">
                  <c:v>13758</c:v>
                </c:pt>
                <c:pt idx="19">
                  <c:v>13087</c:v>
                </c:pt>
                <c:pt idx="20">
                  <c:v>13869</c:v>
                </c:pt>
                <c:pt idx="21">
                  <c:v>11914</c:v>
                </c:pt>
                <c:pt idx="22">
                  <c:v>16492</c:v>
                </c:pt>
                <c:pt idx="23">
                  <c:v>14967</c:v>
                </c:pt>
                <c:pt idx="24">
                  <c:v>14101</c:v>
                </c:pt>
                <c:pt idx="25">
                  <c:v>13038</c:v>
                </c:pt>
                <c:pt idx="26">
                  <c:v>13161</c:v>
                </c:pt>
                <c:pt idx="27">
                  <c:v>12885</c:v>
                </c:pt>
                <c:pt idx="28">
                  <c:v>15061</c:v>
                </c:pt>
                <c:pt idx="29">
                  <c:v>15802</c:v>
                </c:pt>
                <c:pt idx="30">
                  <c:v>12438</c:v>
                </c:pt>
                <c:pt idx="31">
                  <c:v>13137</c:v>
                </c:pt>
                <c:pt idx="32">
                  <c:v>17501</c:v>
                </c:pt>
                <c:pt idx="33">
                  <c:v>18074</c:v>
                </c:pt>
                <c:pt idx="34">
                  <c:v>12523</c:v>
                </c:pt>
                <c:pt idx="35">
                  <c:v>14822</c:v>
                </c:pt>
                <c:pt idx="36">
                  <c:v>15580</c:v>
                </c:pt>
                <c:pt idx="37">
                  <c:v>18735</c:v>
                </c:pt>
                <c:pt idx="38">
                  <c:v>15305</c:v>
                </c:pt>
                <c:pt idx="39">
                  <c:v>15761</c:v>
                </c:pt>
                <c:pt idx="40">
                  <c:v>13406</c:v>
                </c:pt>
                <c:pt idx="41">
                  <c:v>15687</c:v>
                </c:pt>
                <c:pt idx="42">
                  <c:v>16093</c:v>
                </c:pt>
                <c:pt idx="43">
                  <c:v>21799</c:v>
                </c:pt>
                <c:pt idx="44">
                  <c:v>12140</c:v>
                </c:pt>
                <c:pt idx="45">
                  <c:v>21174</c:v>
                </c:pt>
                <c:pt idx="46">
                  <c:v>18790</c:v>
                </c:pt>
                <c:pt idx="47">
                  <c:v>14807</c:v>
                </c:pt>
                <c:pt idx="48">
                  <c:v>17137</c:v>
                </c:pt>
                <c:pt idx="49">
                  <c:v>20016</c:v>
                </c:pt>
                <c:pt idx="50">
                  <c:v>13394</c:v>
                </c:pt>
                <c:pt idx="51">
                  <c:v>14440</c:v>
                </c:pt>
                <c:pt idx="52">
                  <c:v>14885</c:v>
                </c:pt>
                <c:pt idx="53">
                  <c:v>19279</c:v>
                </c:pt>
                <c:pt idx="54">
                  <c:v>17254</c:v>
                </c:pt>
                <c:pt idx="55">
                  <c:v>19312</c:v>
                </c:pt>
                <c:pt idx="56">
                  <c:v>17969</c:v>
                </c:pt>
                <c:pt idx="57">
                  <c:v>18525</c:v>
                </c:pt>
                <c:pt idx="58">
                  <c:v>18227</c:v>
                </c:pt>
                <c:pt idx="59">
                  <c:v>18887</c:v>
                </c:pt>
                <c:pt idx="60">
                  <c:v>20227</c:v>
                </c:pt>
                <c:pt idx="61">
                  <c:v>21642</c:v>
                </c:pt>
                <c:pt idx="62">
                  <c:v>14492</c:v>
                </c:pt>
                <c:pt idx="63">
                  <c:v>20740</c:v>
                </c:pt>
                <c:pt idx="64">
                  <c:v>16613</c:v>
                </c:pt>
                <c:pt idx="65">
                  <c:v>13338</c:v>
                </c:pt>
                <c:pt idx="66">
                  <c:v>20875</c:v>
                </c:pt>
                <c:pt idx="67">
                  <c:v>1743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44A-46F4-8E53-7201793721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1785840"/>
        <c:axId val="411786400"/>
      </c:scatterChart>
      <c:valAx>
        <c:axId val="411785840"/>
        <c:scaling>
          <c:orientation val="minMax"/>
          <c:max val="12000000"/>
          <c:min val="200000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11786400"/>
        <c:crosses val="autoZero"/>
        <c:crossBetween val="midCat"/>
        <c:majorUnit val="2000000"/>
      </c:valAx>
      <c:valAx>
        <c:axId val="411786400"/>
        <c:scaling>
          <c:orientation val="minMax"/>
          <c:max val="22000"/>
          <c:min val="1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117858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0739F283-DD03-4522-ADF4-209B9BE989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>
            <a:extLst>
              <a:ext uri="{FF2B5EF4-FFF2-40B4-BE49-F238E27FC236}">
                <a16:creationId xmlns="" xmlns:a16="http://schemas.microsoft.com/office/drawing/2014/main" id="{D36DE2F7-F1F9-476D-97A9-33C2E4350A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0D3037BE-0768-4527-B77F-B6E231D1D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0814F77E-8B95-4682-B02C-6CC95F846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E4794D12-3C29-4EED-B7CF-2D75B39A4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249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DD795366-FD85-4DAA-B8B4-8FE287C91B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1AD11859-B4D3-4348-8890-795BA68DC6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6B201661-AF57-46C5-9682-1ED536398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E6D71A8B-01F5-4F31-88DC-1A61902A4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6F4956FF-D196-4114-9454-BFC51F546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676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AFE12493-E6F9-44FE-BD89-7D171DEE03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FFA1D5A9-3D2E-46A3-9B99-24F727C79B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9108D8BD-A3B5-42EC-A6C3-295A3730F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52B7C1C0-D5DC-497C-A89F-BECDC17D8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1C71A52A-F117-48C9-B4EA-2B41F51DC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21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B714E2AC-F36B-4D47-83F9-CF1E11E4E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163D9A44-74A2-4EED-A3FA-FA896056D4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D76EE0B7-1FC9-48E2-B358-F60E902756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11D977E2-AE2B-4F92-873A-1D7994695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780B9263-E794-4C8A-A428-AF6D5A648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254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3ECB0F36-DF80-4326-983D-DBAA555CCE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BEBB0935-82B4-4640-B560-89429BE927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A3989C8B-945D-437C-9D30-CEC131E9E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DF9D5536-3565-4D08-B175-A3901F755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A8C8CB24-43D6-4D19-9284-F08A12281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199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C461E684-22A6-417D-BE74-2BEC095AA1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8F3D338D-45BB-49ED-8C5B-8EC68C2CB1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9E189BFC-1E94-4ACC-9081-51BC51CC44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A5D5C770-89C9-4F4F-955A-F25D51D1E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283C60A0-FA21-4CD4-B6E7-D935615B0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DC80B33E-356C-4604-BDD0-BD5D8748A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3741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30474ECD-4266-465C-9492-5D207D8AA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807CCB96-CC52-499D-A7E1-C0C5E45915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C64E9C2B-674D-478B-8EEB-2E4396A8A5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11CAF74A-7798-43F4-8BF6-5A7D995B53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31637DE4-91C1-493E-885B-B5CCF82F98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D00530CE-969E-481D-8DD4-62A242057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EB7CDF43-4474-41B4-83EF-C50C9395E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A25AFD23-5B50-4271-8CAD-1FF3D2377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3973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0E347EA5-B264-4F8F-AC73-2C5412345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3AC075B0-4EE0-453D-836E-F9E11D151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4B617D18-A69B-4EE0-925A-B59DFCC03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620C435B-B064-43FE-9B5F-C19F9C3C8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8884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B1A94383-A2D2-432F-9EFB-4A5C69A80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94009EA9-16C0-4B4E-B99F-2EC5D910C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06218386-7FDA-4A08-BBD6-B46013E41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598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2724EF14-6FFC-4C99-86A9-E362035F57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795E82C6-0D81-451B-BE07-192279BC1F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5B6EE2BD-B170-4FE0-85D2-26016CEE3C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1432C04B-5EB4-406E-B1E8-8F4BF722E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374709B1-A85B-477C-81E0-A0AF6A87D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DDC544A2-8E66-458E-93FD-90770E92B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364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EEB75ED4-2C31-4670-A491-65835DBFDC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A4E889FE-EC6D-4D3D-85AD-D4143AA83E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E1ACCEE9-85F2-431E-92C6-918FAA39E8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067CC125-D585-47C6-A526-D4DA1F636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9BA72B28-7299-4144-A8D7-876122F55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30AE3F2C-83E9-4CC1-BCAF-0C51C1354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730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80EE2D9A-4C15-4762-A8AF-CCFF812B59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F7B5BBBE-B57E-4DD0-931C-840DF5A789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F759ACB1-B04E-4DF7-AE82-049A1DE183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9A44E-CCFA-4F35-B9A4-F5E9D88C21AE}" type="datetimeFigureOut">
              <a:rPr kumimoji="1" lang="ja-JP" altLang="en-US" smtClean="0"/>
              <a:t>2019/4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BDB91E61-1AD7-4F0F-B52F-BD1D262BBB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C2FEAF61-F03B-48C9-9C2A-03E09B0AD3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6A1F4-4ED8-4266-A09C-C3B0AF884B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9940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タイトル 1">
            <a:extLst>
              <a:ext uri="{FF2B5EF4-FFF2-40B4-BE49-F238E27FC236}">
                <a16:creationId xmlns="" xmlns:a16="http://schemas.microsoft.com/office/drawing/2014/main" id="{2C7A0C4E-C97C-47DF-B18A-70FE4BC7A2AB}"/>
              </a:ext>
            </a:extLst>
          </p:cNvPr>
          <p:cNvSpPr txBox="1">
            <a:spLocks/>
          </p:cNvSpPr>
          <p:nvPr/>
        </p:nvSpPr>
        <p:spPr>
          <a:xfrm>
            <a:off x="263866" y="6101544"/>
            <a:ext cx="11645185" cy="5024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rPr>
              <a:t>Supplementary Figure 1. </a:t>
            </a:r>
            <a:r>
              <a:rPr lang="ja-JP" altLang="ja-JP" sz="24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Scattered plot between </a:t>
            </a:r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read number and </a:t>
            </a:r>
            <a:r>
              <a:rPr lang="ja-JP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number </a:t>
            </a:r>
            <a:r>
              <a:rPr lang="ja-JP" altLang="ja-JP" sz="24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of predicted </a:t>
            </a:r>
            <a:r>
              <a:rPr lang="ja-JP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transcripts</a:t>
            </a:r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 for RNA-</a:t>
            </a:r>
            <a:r>
              <a:rPr lang="en-US" altLang="ja-JP" sz="2400" dirty="0" err="1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seq</a:t>
            </a:r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 library</a:t>
            </a:r>
            <a:r>
              <a:rPr lang="ja-JP" altLang="ja-JP" sz="2400" dirty="0" err="1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.</a:t>
            </a:r>
            <a:endParaRPr lang="ja-JP" altLang="ja-JP" sz="24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="" xmlns:a16="http://schemas.microsoft.com/office/drawing/2014/main" id="{05072979-BB2E-4BD7-8966-1D1512415E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4821958"/>
              </p:ext>
            </p:extLst>
          </p:nvPr>
        </p:nvGraphicFramePr>
        <p:xfrm>
          <a:off x="1137304" y="422806"/>
          <a:ext cx="8943956" cy="4972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タイトル 1">
            <a:extLst>
              <a:ext uri="{FF2B5EF4-FFF2-40B4-BE49-F238E27FC236}">
                <a16:creationId xmlns="" xmlns:a16="http://schemas.microsoft.com/office/drawing/2014/main" id="{4985857A-2F50-474F-AE89-2C476C96F118}"/>
              </a:ext>
            </a:extLst>
          </p:cNvPr>
          <p:cNvSpPr txBox="1">
            <a:spLocks/>
          </p:cNvSpPr>
          <p:nvPr/>
        </p:nvSpPr>
        <p:spPr>
          <a:xfrm>
            <a:off x="4199596" y="5405584"/>
            <a:ext cx="3253057" cy="5024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Read </a:t>
            </a:r>
            <a:r>
              <a:rPr lang="en-US" altLang="ja-JP" sz="240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number</a:t>
            </a:r>
            <a:endParaRPr lang="ja-JP" altLang="ja-JP" sz="24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5" name="タイトル 1">
            <a:extLst>
              <a:ext uri="{FF2B5EF4-FFF2-40B4-BE49-F238E27FC236}">
                <a16:creationId xmlns="" xmlns:a16="http://schemas.microsoft.com/office/drawing/2014/main" id="{DF9D5A9F-A74A-4744-BDEB-E6D3415560D0}"/>
              </a:ext>
            </a:extLst>
          </p:cNvPr>
          <p:cNvSpPr txBox="1">
            <a:spLocks/>
          </p:cNvSpPr>
          <p:nvPr/>
        </p:nvSpPr>
        <p:spPr>
          <a:xfrm rot="16200000">
            <a:off x="-1011528" y="2410924"/>
            <a:ext cx="3603082" cy="5024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Number </a:t>
            </a:r>
            <a:r>
              <a:rPr lang="en-US" altLang="ja-JP" sz="24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of </a:t>
            </a:r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transcripts</a:t>
            </a:r>
            <a:endParaRPr lang="ja-JP" altLang="ja-JP" sz="24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3632504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タイトル 1">
            <a:extLst>
              <a:ext uri="{FF2B5EF4-FFF2-40B4-BE49-F238E27FC236}">
                <a16:creationId xmlns="" xmlns:a16="http://schemas.microsoft.com/office/drawing/2014/main" id="{2C7A0C4E-C97C-47DF-B18A-70FE4BC7A2AB}"/>
              </a:ext>
            </a:extLst>
          </p:cNvPr>
          <p:cNvSpPr txBox="1">
            <a:spLocks/>
          </p:cNvSpPr>
          <p:nvPr/>
        </p:nvSpPr>
        <p:spPr>
          <a:xfrm>
            <a:off x="263866" y="6101544"/>
            <a:ext cx="11645185" cy="5024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メイリオ" panose="020B0604030504040204" pitchFamily="50" charset="-128"/>
                <a:ea typeface="メイリオ" panose="020B0604030504040204" pitchFamily="50" charset="-128"/>
                <a:cs typeface="Arial" panose="020B0604020202020204" pitchFamily="34" charset="0"/>
              </a:rPr>
              <a:t>Supplementary Figure 2. </a:t>
            </a:r>
            <a:r>
              <a:rPr lang="ja-JP" altLang="ja-JP" sz="24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Scattered plot between </a:t>
            </a:r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read number </a:t>
            </a:r>
            <a:r>
              <a:rPr lang="en-US" altLang="ja-JP" sz="24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and </a:t>
            </a:r>
            <a:r>
              <a:rPr lang="ja-JP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number </a:t>
            </a:r>
            <a:r>
              <a:rPr lang="ja-JP" altLang="ja-JP" sz="24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of </a:t>
            </a:r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SNPs for each accession</a:t>
            </a:r>
            <a:r>
              <a:rPr lang="ja-JP" altLang="ja-JP" sz="2400" dirty="0" err="1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.</a:t>
            </a:r>
            <a:endParaRPr lang="ja-JP" altLang="ja-JP" sz="24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="" xmlns:a16="http://schemas.microsoft.com/office/drawing/2014/main" id="{894A98C1-FB12-4FE0-B416-458CBBC26A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7270013"/>
              </p:ext>
            </p:extLst>
          </p:nvPr>
        </p:nvGraphicFramePr>
        <p:xfrm>
          <a:off x="1582615" y="254000"/>
          <a:ext cx="9104435" cy="5151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タイトル 1">
            <a:extLst>
              <a:ext uri="{FF2B5EF4-FFF2-40B4-BE49-F238E27FC236}">
                <a16:creationId xmlns="" xmlns:a16="http://schemas.microsoft.com/office/drawing/2014/main" id="{2FFA1BAE-6099-40BB-B207-2AFE61F08733}"/>
              </a:ext>
            </a:extLst>
          </p:cNvPr>
          <p:cNvSpPr txBox="1">
            <a:spLocks/>
          </p:cNvSpPr>
          <p:nvPr/>
        </p:nvSpPr>
        <p:spPr>
          <a:xfrm>
            <a:off x="4199596" y="5405584"/>
            <a:ext cx="3253057" cy="5024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Read number</a:t>
            </a:r>
            <a:endParaRPr lang="ja-JP" altLang="ja-JP" sz="24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7" name="タイトル 1">
            <a:extLst>
              <a:ext uri="{FF2B5EF4-FFF2-40B4-BE49-F238E27FC236}">
                <a16:creationId xmlns="" xmlns:a16="http://schemas.microsoft.com/office/drawing/2014/main" id="{0A394E10-9B86-45C4-8B60-F25F840B892C}"/>
              </a:ext>
            </a:extLst>
          </p:cNvPr>
          <p:cNvSpPr txBox="1">
            <a:spLocks/>
          </p:cNvSpPr>
          <p:nvPr/>
        </p:nvSpPr>
        <p:spPr>
          <a:xfrm rot="16200000">
            <a:off x="-516779" y="2578564"/>
            <a:ext cx="3541001" cy="502456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2400" dirty="0" smtClean="0">
                <a:latin typeface="メイリオ" panose="020B0604030504040204" pitchFamily="50" charset="-128"/>
                <a:ea typeface="メイリオ" panose="020B0604030504040204" pitchFamily="50" charset="-128"/>
              </a:rPr>
              <a:t>Numbers </a:t>
            </a:r>
            <a:r>
              <a:rPr lang="en-US" altLang="ja-JP" sz="2400" dirty="0">
                <a:latin typeface="メイリオ" panose="020B0604030504040204" pitchFamily="50" charset="-128"/>
                <a:ea typeface="メイリオ" panose="020B0604030504040204" pitchFamily="50" charset="-128"/>
              </a:rPr>
              <a:t>of SNPs</a:t>
            </a:r>
            <a:endParaRPr lang="ja-JP" altLang="ja-JP" sz="2400" dirty="0"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570783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85</TotalTime>
  <Words>45</Words>
  <Application>Microsoft Office PowerPoint</Application>
  <PresentationFormat>ワイド画面</PresentationFormat>
  <Paragraphs>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メイリオ</vt:lpstr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 Distribution of difference of mapping ratio between Whole genome and transcribed regions</dc:title>
  <dc:creator>tstanaka</dc:creator>
  <cp:lastModifiedBy>sato</cp:lastModifiedBy>
  <cp:revision>84</cp:revision>
  <dcterms:created xsi:type="dcterms:W3CDTF">2018-07-02T06:57:58Z</dcterms:created>
  <dcterms:modified xsi:type="dcterms:W3CDTF">2019-04-08T05:29:30Z</dcterms:modified>
</cp:coreProperties>
</file>